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545" autoAdjust="0"/>
    <p:restoredTop sz="94660"/>
  </p:normalViewPr>
  <p:slideViewPr>
    <p:cSldViewPr>
      <p:cViewPr varScale="1">
        <p:scale>
          <a:sx n="105" d="100"/>
          <a:sy n="105" d="100"/>
        </p:scale>
        <p:origin x="2352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511A5A-D56C-4500-8104-1810348C0D9F}" type="datetimeFigureOut">
              <a:rPr lang="en-US" smtClean="0"/>
              <a:t>07-Mar-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D0039C-DF8C-4DC8-8E3A-2CFF63274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844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D0039C-DF8C-4DC8-8E3A-2CFF63274AA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2247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07-Mar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1E38E02-B307-43C8-9960-C8A95A688BA4}"/>
              </a:ext>
            </a:extLst>
          </p:cNvPr>
          <p:cNvSpPr txBox="1"/>
          <p:nvPr/>
        </p:nvSpPr>
        <p:spPr>
          <a:xfrm>
            <a:off x="98868" y="4419600"/>
            <a:ext cx="8964488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8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ar </a:t>
            </a:r>
            <a:r>
              <a:rPr lang="en-US" sz="8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STn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the duplicated </a:t>
            </a:r>
            <a:r>
              <a:rPr lang="en-US" sz="8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 of LC-1302-2020. The coordinates shown above and below (in bp) correspond to the duplicated region carrying </a:t>
            </a:r>
            <a:r>
              <a:rPr lang="en-US" sz="8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</a:t>
            </a:r>
            <a:r>
              <a:rPr lang="en-US" sz="8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and Tn</a:t>
            </a:r>
            <a:r>
              <a:rPr lang="en-US" sz="8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03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1-LC-1302-2020-KPC (below) and in p1-LC-1303-2020-KPC (above). The total duplicated region (in kb) and coordinates are shown below. For visualization, only representative </a:t>
            </a:r>
            <a:r>
              <a:rPr lang="en-US" sz="8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are shown in purple, Tn</a:t>
            </a:r>
            <a:r>
              <a:rPr lang="en-US" sz="8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03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black, and other CDS in turquoise. The linear </a:t>
            </a:r>
            <a:r>
              <a:rPr lang="en-US" sz="8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STn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was generated with </a:t>
            </a:r>
            <a:r>
              <a:rPr lang="en-US" sz="8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syfig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.2.2.2. Similarities are represented by the grey area between the sequence alignment; black lines represent </a:t>
            </a:r>
            <a:r>
              <a:rPr lang="en-US" sz="8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STn</a:t>
            </a:r>
            <a:r>
              <a:rPr lang="en-US" sz="8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ts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1828800"/>
            <a:ext cx="8915400" cy="2426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84624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mpos-Madueno, Edgar Igor (IFIK)</dc:creator>
  <cp:lastModifiedBy>Endimiani, Andrea (IFIK)</cp:lastModifiedBy>
  <cp:revision>59</cp:revision>
  <dcterms:created xsi:type="dcterms:W3CDTF">2006-08-16T00:00:00Z</dcterms:created>
  <dcterms:modified xsi:type="dcterms:W3CDTF">2022-03-07T15:14:56Z</dcterms:modified>
</cp:coreProperties>
</file>